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tiff" ContentType="image/tiff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  <p:sldId id="259" r:id="rId5"/>
    <p:sldId id="260" r:id="rId6"/>
    <p:sldId id="265" r:id="rId7"/>
    <p:sldId id="264" r:id="rId8"/>
    <p:sldId id="266" r:id="rId9"/>
    <p:sldId id="267" r:id="rId10"/>
  </p:sldIdLst>
  <p:sldSz cx="12192000" cy="6858000"/>
  <p:notesSz cx="6858000" cy="9144000"/>
  <p:custDataLst>
    <p:tags r:id="rId1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629" autoAdjust="0"/>
  </p:normalViewPr>
  <p:slideViewPr>
    <p:cSldViewPr snapToGrid="0">
      <p:cViewPr varScale="1">
        <p:scale>
          <a:sx n="129" d="100"/>
          <a:sy n="129" d="100"/>
        </p:scale>
        <p:origin x="580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gs" Target="tags/tag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992378-29DC-4D73-B17A-B8451A7374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40DB3B-A3BE-491B-B179-B3F8CA5057F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40DB3B-A3BE-491B-B179-B3F8CA5057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F6D79A-67ED-4599-8560-4B8560041BE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40DB3B-A3BE-491B-B179-B3F8CA5057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F6D79A-67ED-4599-8560-4B8560041BE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bisProAB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F6D79A-67ED-4599-8560-4B8560041BE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17CCB-04DA-42CF-91E9-25D8412627E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7A51F-CB40-4471-A421-FE729A620FDA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vmlDrawing" Target="../drawings/vmlDrawing1.vml"/><Relationship Id="rId8" Type="http://schemas.openxmlformats.org/officeDocument/2006/relationships/slideLayout" Target="../slideLayouts/slideLayout2.xml"/><Relationship Id="rId7" Type="http://schemas.openxmlformats.org/officeDocument/2006/relationships/image" Target="../media/image6.emf"/><Relationship Id="rId6" Type="http://schemas.openxmlformats.org/officeDocument/2006/relationships/oleObject" Target="../embeddings/oleObject1.bin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0" Type="http://schemas.openxmlformats.org/officeDocument/2006/relationships/notesSlide" Target="../notesSlides/notesSlide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27.tiff"/><Relationship Id="rId8" Type="http://schemas.openxmlformats.org/officeDocument/2006/relationships/image" Target="../media/image26.tiff"/><Relationship Id="rId7" Type="http://schemas.openxmlformats.org/officeDocument/2006/relationships/image" Target="../media/image25.tiff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1" Type="http://schemas.openxmlformats.org/officeDocument/2006/relationships/notesSlide" Target="../notesSlides/notesSlide2.xml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9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3.x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image" Target="../media/image28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42.tiff"/><Relationship Id="rId8" Type="http://schemas.openxmlformats.org/officeDocument/2006/relationships/image" Target="../media/image41.tiff"/><Relationship Id="rId7" Type="http://schemas.openxmlformats.org/officeDocument/2006/relationships/image" Target="../media/image40.tiff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4" Type="http://schemas.openxmlformats.org/officeDocument/2006/relationships/notesSlide" Target="../notesSlides/notesSlide4.xml"/><Relationship Id="rId13" Type="http://schemas.openxmlformats.org/officeDocument/2006/relationships/slideLayout" Target="../slideLayouts/slideLayout2.xml"/><Relationship Id="rId12" Type="http://schemas.openxmlformats.org/officeDocument/2006/relationships/image" Target="../media/image45.tiff"/><Relationship Id="rId11" Type="http://schemas.openxmlformats.org/officeDocument/2006/relationships/image" Target="../media/image44.tiff"/><Relationship Id="rId10" Type="http://schemas.openxmlformats.org/officeDocument/2006/relationships/image" Target="../media/image43.tiff"/><Relationship Id="rId1" Type="http://schemas.openxmlformats.org/officeDocument/2006/relationships/image" Target="../media/image34.tiff"/></Relationships>
</file>

<file path=ppt/slides/_rels/slide7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5.xml"/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image" Target="../media/image4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69882" y="5647329"/>
            <a:ext cx="11399778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: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BR green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PCR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s.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–C) (A) bisACTB_103_F1 + bisACTB_103_R1, (B) bisACTB_103_F2 + bisACTB_103_R2, and (C) bisACTB_103_F2_17C + bisACTB_103_R2 primer combinations for the mel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s of bisHela, gHela, and BC. (D–F) (D) bisACTB_103_F1 + bisACTB_103_R1, (E) bisACTB_103_F2 + bisACTB_103_R2, and (F) bisACTB_103_F2_17C + bisACTB_103_R2 primer combinations for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s of bisHel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olid line with triangle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Hela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squar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, and BC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circl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370205" y="517525"/>
            <a:ext cx="11401425" cy="5128895"/>
            <a:chOff x="583" y="815"/>
            <a:chExt cx="17955" cy="8077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68" y="4698"/>
              <a:ext cx="6067" cy="4195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14" y="815"/>
              <a:ext cx="6024" cy="3936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0" y="4698"/>
              <a:ext cx="6067" cy="4195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6" y="4698"/>
              <a:ext cx="6067" cy="4195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6" y="815"/>
              <a:ext cx="6024" cy="3883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583" y="843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583" y="4698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6526" y="822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6544" y="4751"/>
              <a:ext cx="505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2530" y="843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2511" y="4698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3195" y="843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1 + R1</a:t>
              </a:r>
              <a:endParaRPr lang="zh-CN" altLang="en-US" sz="1000" dirty="0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9182" y="843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2 + R2</a:t>
              </a:r>
              <a:endParaRPr lang="zh-CN" altLang="en-US" sz="1000" dirty="0"/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4726" y="843"/>
              <a:ext cx="3812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2_17C + R2</a:t>
              </a:r>
              <a:endParaRPr lang="zh-CN" altLang="en-US" sz="1000" dirty="0"/>
            </a:p>
          </p:txBody>
        </p:sp>
        <p:graphicFrame>
          <p:nvGraphicFramePr>
            <p:cNvPr id="8" name="对象 7"/>
            <p:cNvGraphicFramePr/>
            <p:nvPr/>
          </p:nvGraphicFramePr>
          <p:xfrm>
            <a:off x="6559" y="815"/>
            <a:ext cx="5992" cy="38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" name="" r:id="rId6" imgW="3857625" imgH="2447925" progId="Prism8.Document">
                    <p:embed/>
                  </p:oleObj>
                </mc:Choice>
                <mc:Fallback>
                  <p:oleObj name="" r:id="rId6" imgW="3857625" imgH="2447925" progId="Prism8.Document">
                    <p:embed/>
                    <p:pic>
                      <p:nvPicPr>
                        <p:cNvPr id="0" name="图片 11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559" y="815"/>
                          <a:ext cx="5992" cy="38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/>
          <p:cNvSpPr txBox="1"/>
          <p:nvPr/>
        </p:nvSpPr>
        <p:spPr>
          <a:xfrm>
            <a:off x="9727951" y="790160"/>
            <a:ext cx="24204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 + R</a:t>
            </a:r>
            <a:endParaRPr lang="zh-CN" altLang="en-US" sz="1000" dirty="0"/>
          </a:p>
        </p:txBody>
      </p:sp>
      <p:sp>
        <p:nvSpPr>
          <p:cNvPr id="2" name="文本框 1"/>
          <p:cNvSpPr txBox="1"/>
          <p:nvPr/>
        </p:nvSpPr>
        <p:spPr>
          <a:xfrm>
            <a:off x="369882" y="5884579"/>
            <a:ext cx="11399778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: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YBR green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s.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–C) (A) bisACTB_89_FP + bisACTB_89_RP-1, (B) bisACTB_89_FP + bisACTB_89_RP-2, and (C) bisACTB_89_F + bisACTB_89_R primer combinations for the mel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s of bisHela, gHela, and BC. (D–F) (D) bisACTB_89_FP + bisACTB_89_RP-1, (E) bisACTB_89_FP + bisACTB_89_RP-2, and (F) bisACTB_89_F + bisACTB_89_R primer combinations for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s of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isHel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triangl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gHela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squar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, and BC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circl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318770" y="789940"/>
            <a:ext cx="11553825" cy="5141595"/>
            <a:chOff x="502" y="1244"/>
            <a:chExt cx="18195" cy="8097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2" y="1252"/>
              <a:ext cx="6024" cy="3883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2" y="5135"/>
              <a:ext cx="6067" cy="4195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9" y="1252"/>
              <a:ext cx="6062" cy="3902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31" y="1252"/>
              <a:ext cx="6024" cy="3883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31" y="5135"/>
              <a:ext cx="6067" cy="4195"/>
            </a:xfrm>
            <a:prstGeom prst="rect">
              <a:avLst/>
            </a:prstGeom>
          </p:spPr>
        </p:pic>
        <p:sp>
          <p:nvSpPr>
            <p:cNvPr id="28" name="文本框 27"/>
            <p:cNvSpPr txBox="1"/>
            <p:nvPr/>
          </p:nvSpPr>
          <p:spPr>
            <a:xfrm>
              <a:off x="3190" y="1244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P + RP-1</a:t>
              </a:r>
              <a:endParaRPr lang="zh-CN" altLang="en-US" sz="1000" dirty="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9214" y="1244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P + RP-2</a:t>
              </a:r>
              <a:endParaRPr lang="zh-CN" altLang="en-US" sz="1000" dirty="0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502" y="1244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502" y="5147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6564" y="1244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6564" y="5162"/>
              <a:ext cx="505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2608" y="1244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2636" y="5128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4" y="5147"/>
              <a:ext cx="6067" cy="4195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71145" y="829945"/>
            <a:ext cx="11825605" cy="5133975"/>
            <a:chOff x="427" y="1307"/>
            <a:chExt cx="18623" cy="8085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9" y="1315"/>
              <a:ext cx="6024" cy="3883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9" y="5198"/>
              <a:ext cx="6067" cy="4195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" y="1315"/>
              <a:ext cx="6024" cy="3883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" y="5198"/>
              <a:ext cx="6067" cy="4195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49" y="1315"/>
              <a:ext cx="6024" cy="3883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06" y="5198"/>
              <a:ext cx="6067" cy="4195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/>
          </p:nvSpPr>
          <p:spPr>
            <a:xfrm>
              <a:off x="3303" y="1315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2 + R2</a:t>
              </a:r>
              <a:endParaRPr lang="zh-CN" altLang="en-US" sz="1000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9214" y="1315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3 + R</a:t>
              </a:r>
              <a:endParaRPr lang="zh-CN" altLang="en-US" sz="1000" dirty="0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5238" y="1315"/>
              <a:ext cx="3812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3_19C + 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427" y="1407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6634" y="1315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2663" y="1307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29" y="5290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6556" y="5198"/>
              <a:ext cx="505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12706" y="5206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335346" y="5858883"/>
            <a:ext cx="11399778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: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YBR green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s.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–C) (A) bisACTB_78_F2 + bisACTB_78_R2, (B) bisACTB_78_F23 + bisACTB_89_R, and (C) bisACTB_78_F3_19C + bisACTB_89_R primer combinations for the mel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s of bisHela, gHela, and BC. (D–F) (D) bisACTB_78_F2 + bisACTB_78_R2, (E) bisACTB_78_F23 + bisACTB_78_R, and (F) bisACTB_78_F3_19C + bisACTB_89_R primer combinations for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s of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isHel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triangl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gHela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squar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, and BC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circl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83870" y="85090"/>
            <a:ext cx="10806430" cy="6181090"/>
            <a:chOff x="460" y="-261"/>
            <a:chExt cx="18255" cy="11215"/>
          </a:xfrm>
        </p:grpSpPr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91" y="-244"/>
              <a:ext cx="6077" cy="3725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" y="-215"/>
              <a:ext cx="6077" cy="3725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38" y="-230"/>
              <a:ext cx="6077" cy="3725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485" y="-231"/>
              <a:ext cx="52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6537" y="-261"/>
              <a:ext cx="52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2614" y="-259"/>
              <a:ext cx="52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270" y="-188"/>
              <a:ext cx="1333" cy="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s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9322" y="-239"/>
              <a:ext cx="1026" cy="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5677" y="-188"/>
              <a:ext cx="912" cy="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2" y="3509"/>
              <a:ext cx="6077" cy="3725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" y="3481"/>
              <a:ext cx="6077" cy="3725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14" y="3500"/>
              <a:ext cx="6077" cy="3725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3" y="7220"/>
              <a:ext cx="6077" cy="3725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0" y="7220"/>
              <a:ext cx="6077" cy="3706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04" y="7230"/>
              <a:ext cx="6077" cy="3725"/>
            </a:xfrm>
            <a:prstGeom prst="rect">
              <a:avLst/>
            </a:prstGeom>
          </p:spPr>
        </p:pic>
        <p:sp>
          <p:nvSpPr>
            <p:cNvPr id="39" name="文本框 38"/>
            <p:cNvSpPr txBox="1"/>
            <p:nvPr/>
          </p:nvSpPr>
          <p:spPr>
            <a:xfrm>
              <a:off x="460" y="3522"/>
              <a:ext cx="52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512" y="3492"/>
              <a:ext cx="505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2589" y="3493"/>
              <a:ext cx="488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485" y="7217"/>
              <a:ext cx="54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6537" y="7187"/>
              <a:ext cx="523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2614" y="7189"/>
              <a:ext cx="382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483235" y="6205855"/>
            <a:ext cx="10792460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4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. Amplification profiles from TaqMan probe-based qPCR assays.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(A~C) Amplification curves of bisACTB_103 primer-probe sets for (A) bisHeLa, (B) gHeLa, and (C) blank control (BC). (D~F) Amplification curves of bisACTB_89 primer-probe sets for (D) bisHeLa, (E) gHeLa, and (F) BC. (G~I) Amplification curves of bisACTB_78 primer-probe sets for (G) bisHeLa, (H) gHeLa, and (I) BC.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32"/>
          <p:cNvSpPr txBox="1"/>
          <p:nvPr/>
        </p:nvSpPr>
        <p:spPr>
          <a:xfrm>
            <a:off x="9902389" y="587867"/>
            <a:ext cx="24204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zh-CN" altLang="en-US" sz="1000" dirty="0"/>
          </a:p>
        </p:txBody>
      </p:sp>
      <p:sp>
        <p:nvSpPr>
          <p:cNvPr id="2" name="文本框 1"/>
          <p:cNvSpPr txBox="1"/>
          <p:nvPr/>
        </p:nvSpPr>
        <p:spPr>
          <a:xfrm>
            <a:off x="358521" y="5728230"/>
            <a:ext cx="11399778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YBR green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s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–C) bisProAB1_F + bisProAB1_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dashed line with circle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isProAB1_F1 + bisProAB1_R1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squar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, and bisProAB1_F2 + bisProAB1_R2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（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olid line with triangl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er combinations for (A) bisHela, (B) gHela, and (C) BC mel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s. (D–F) bisProAB1_F + bisProAB1_R, bisProAB1_F1 + bisProAB1_R1, and bisProAB1_F2 + bisProAB1_R2 primer combinations for (D) bisHela, (E) gHela, and (F) BC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s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351790" y="555625"/>
            <a:ext cx="11494135" cy="5153660"/>
            <a:chOff x="554" y="875"/>
            <a:chExt cx="18101" cy="8116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82" y="894"/>
              <a:ext cx="6024" cy="3883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89" y="4758"/>
              <a:ext cx="6067" cy="4195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" y="914"/>
              <a:ext cx="6024" cy="3883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" y="875"/>
              <a:ext cx="6024" cy="3883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/>
          </p:nvSpPr>
          <p:spPr>
            <a:xfrm>
              <a:off x="3309" y="934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sHela</a:t>
              </a:r>
              <a:endParaRPr lang="zh-CN" altLang="en-US" sz="1000" dirty="0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9256" y="926"/>
              <a:ext cx="3336" cy="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Hela</a:t>
              </a:r>
              <a:endParaRPr lang="zh-CN" altLang="en-US" sz="1000" dirty="0"/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" y="4767"/>
              <a:ext cx="6067" cy="4195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" y="4797"/>
              <a:ext cx="6067" cy="4195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565" y="894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6550" y="893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2578" y="913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573" y="4740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6583" y="4738"/>
              <a:ext cx="505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2578" y="4740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23265" y="7784465"/>
            <a:ext cx="8891905" cy="1014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6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. Amplification profiles from TaqMan probe-based qPCR assays. 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(A-C) Amplification curves generated by the bisAB1_F4/R4/P4 primer-probe set for (A) bisHeLa (B) gHeLa, and (C) blank control (BC). (D-F) Amplification curves produced by the bisAB1_F4/R4-2/P4 combination for (D) bisHeLa, (E) gHeLa, and (F) BC. (G-I) Amplification profiles obtained with the bisAB1_F4-2/R4/P4 set for (G) bisHeLa, (H) gHeLa, and (I) BC. (J-L) Amplification curves using the bisAB2_F4/R4/P4 system for (J) bisHeLa, (K) gHeLa, and (L) BC. 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5" name="组合 84"/>
          <p:cNvGrpSpPr/>
          <p:nvPr/>
        </p:nvGrpSpPr>
        <p:grpSpPr>
          <a:xfrm>
            <a:off x="359410" y="-1731010"/>
            <a:ext cx="11602720" cy="9486265"/>
            <a:chOff x="566" y="-2726"/>
            <a:chExt cx="18272" cy="14939"/>
          </a:xfrm>
        </p:grpSpPr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44" y="8462"/>
              <a:ext cx="6077" cy="3725"/>
            </a:xfrm>
            <a:prstGeom prst="rect">
              <a:avLst/>
            </a:prstGeom>
          </p:spPr>
        </p:pic>
        <p:pic>
          <p:nvPicPr>
            <p:cNvPr id="59" name="图片 5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" y="8489"/>
              <a:ext cx="6077" cy="3725"/>
            </a:xfrm>
            <a:prstGeom prst="rect">
              <a:avLst/>
            </a:prstGeom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8" y="8489"/>
              <a:ext cx="6077" cy="3725"/>
            </a:xfrm>
            <a:prstGeom prst="rect">
              <a:avLst/>
            </a:prstGeom>
          </p:spPr>
        </p:pic>
        <p:pic>
          <p:nvPicPr>
            <p:cNvPr id="61" name="图片 60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62" y="4751"/>
              <a:ext cx="6077" cy="3725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8" y="4738"/>
              <a:ext cx="6077" cy="3725"/>
            </a:xfrm>
            <a:prstGeom prst="rect">
              <a:avLst/>
            </a:prstGeom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8" y="4724"/>
              <a:ext cx="6077" cy="3725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62" y="1004"/>
              <a:ext cx="6077" cy="3725"/>
            </a:xfrm>
            <a:prstGeom prst="rect">
              <a:avLst/>
            </a:prstGeom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8" y="1004"/>
              <a:ext cx="6077" cy="3725"/>
            </a:xfrm>
            <a:prstGeom prst="rect">
              <a:avLst/>
            </a:prstGeom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1" y="1016"/>
              <a:ext cx="6077" cy="3725"/>
            </a:xfrm>
            <a:prstGeom prst="rect">
              <a:avLst/>
            </a:prstGeom>
          </p:spPr>
        </p:pic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62" y="-2709"/>
              <a:ext cx="6077" cy="3725"/>
            </a:xfrm>
            <a:prstGeom prst="rect">
              <a:avLst/>
            </a:prstGeom>
          </p:spPr>
        </p:pic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8" y="-2694"/>
              <a:ext cx="6077" cy="3725"/>
            </a:xfrm>
            <a:prstGeom prst="rect">
              <a:avLst/>
            </a:prstGeom>
          </p:spPr>
        </p:pic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6" y="-2709"/>
              <a:ext cx="6077" cy="3725"/>
            </a:xfrm>
            <a:prstGeom prst="rect">
              <a:avLst/>
            </a:prstGeom>
          </p:spPr>
        </p:pic>
        <p:sp>
          <p:nvSpPr>
            <p:cNvPr id="70" name="文本框 69"/>
            <p:cNvSpPr txBox="1"/>
            <p:nvPr/>
          </p:nvSpPr>
          <p:spPr>
            <a:xfrm>
              <a:off x="616" y="-2667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6668" y="-2697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12744" y="-2696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616" y="1086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6668" y="1056"/>
              <a:ext cx="505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12744" y="1058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591" y="4811"/>
              <a:ext cx="54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6643" y="4781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2720" y="4782"/>
              <a:ext cx="382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91" y="8530"/>
              <a:ext cx="470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6643" y="8500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12720" y="8501"/>
              <a:ext cx="488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3211" y="-2705"/>
              <a:ext cx="1005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s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9263" y="-2726"/>
              <a:ext cx="839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15618" y="-2705"/>
              <a:ext cx="584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374454" y="4284837"/>
            <a:ext cx="11554685" cy="4603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7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. Amplification profiles of bisProAB1 primer-probe sets in TaqMan qPCR assays.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(A-C) Amplification curves for (A) bisHeLa, (B) gHeLa, and (C) blank control (BC).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398145" y="1833880"/>
            <a:ext cx="11594465" cy="2458720"/>
            <a:chOff x="627" y="2888"/>
            <a:chExt cx="18259" cy="3872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10" y="3030"/>
              <a:ext cx="6077" cy="3725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" y="3036"/>
              <a:ext cx="6077" cy="3725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34" y="3036"/>
              <a:ext cx="6077" cy="3725"/>
            </a:xfrm>
            <a:prstGeom prst="rect">
              <a:avLst/>
            </a:prstGeom>
          </p:spPr>
        </p:pic>
        <p:sp>
          <p:nvSpPr>
            <p:cNvPr id="2" name="文本框 1"/>
            <p:cNvSpPr txBox="1"/>
            <p:nvPr/>
          </p:nvSpPr>
          <p:spPr>
            <a:xfrm>
              <a:off x="627" y="3066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6679" y="3036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12755" y="3038"/>
              <a:ext cx="523" cy="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380" y="2888"/>
              <a:ext cx="1005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s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9432" y="2888"/>
              <a:ext cx="839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Hel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5787" y="2888"/>
              <a:ext cx="584" cy="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mU1N2E4NGFmYzk5MzhlOTJjZTkyYzY2NmY5ZmUzOTk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59</Words>
  <Application>WPS 演示</Application>
  <PresentationFormat>宽屏</PresentationFormat>
  <Paragraphs>152</Paragraphs>
  <Slides>7</Slides>
  <Notes>2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7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Office 主题​​</vt:lpstr>
      <vt:lpstr>Prism8.Documen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ng chen</dc:creator>
  <cp:lastModifiedBy>小灵子</cp:lastModifiedBy>
  <cp:revision>117</cp:revision>
  <dcterms:created xsi:type="dcterms:W3CDTF">2024-07-16T09:17:00Z</dcterms:created>
  <dcterms:modified xsi:type="dcterms:W3CDTF">2025-11-02T02:10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57F95010DD44F4197301815803531F3_12</vt:lpwstr>
  </property>
  <property fmtid="{D5CDD505-2E9C-101B-9397-08002B2CF9AE}" pid="3" name="KSOProductBuildVer">
    <vt:lpwstr>2052-12.1.0.23125</vt:lpwstr>
  </property>
</Properties>
</file>